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23098F-A7E6-4CD9-BCBB-E8F34F23BB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246E2A-A9D6-4C02-8701-E6D6C2BFBC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73B185-E9B1-4695-9AAF-31E2C04E56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AEA4B-1C90-4FE4-BF1B-5E9121A587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4C03D3-E211-4276-BA22-3BB39A6ABB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AF4AD-2D07-49D1-B2EA-700A3BD9D1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023E4-98A6-4F3E-A100-25B8416C40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974C4B-1673-4DDE-A1B0-5C2A1FBF48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059CEF-7B8C-40BF-80F0-9F005F54B9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06E13E-6DB3-4EAA-92A5-5E9ED3125D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DA3CFC-220A-4188-807B-EFF412B039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673FFD-4423-4389-8537-66F49A2D4D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96BC9D-506D-4DBF-A55F-30931BABDC3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mailto:jada.lewis@mbi.ufl.edu" TargetMode="External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85800" y="1127160"/>
            <a:ext cx="5486400" cy="4559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Journ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cta Neuropathologi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it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euronal Sensitivity to TDP-43 Overexpression is Dependent on Timing of Indu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uthors and Affiliatio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hley Cannon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Baoli Yang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Joshua Knight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, 3, 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Ian M. Farnha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Yongjie Zhang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Charles A. Wuertze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Simon D’Alton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, 3, 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Wen-lang Lin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Monica Castanedes-Casey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Linda Rousseau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Brittany Scott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Michael Jurasic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John Howard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, 3, 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Xin Yu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Rachel Bailey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, 3, 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Matthew R. Sarkisian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Dennis W. Dickson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Leonard Petrucelli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Jada Lewis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, 3, 4,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partment of Neuroscience, Mayo Clinic, Jacksonville, Florida 32224, US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partment of Obstetrics and Gynecology, University of Iowa, Iowa City, IA 52242, US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partment of Neuroscience, University of Florida, Gainesville, FL 32611, US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enter for Translational Research in Neurodegenerative Disease, University of Florida, Gainesville, FL 32611, US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Correspondence: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Email: </a:t>
            </a:r>
            <a:r>
              <a:rPr b="0" lang="fr-FR" sz="1000" spc="-1" strike="noStrike" u="sng">
                <a:solidFill>
                  <a:srgbClr val="009999"/>
                </a:solidFill>
                <a:uFillTx/>
                <a:latin typeface="Arial"/>
                <a:hlinkClick r:id="rId1"/>
              </a:rPr>
              <a:t>jada.lewis@mbi.ufl.edu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Phone: (352) 273-966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Fax: (352) 294-50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" name=""/>
          <p:cNvGraphicFramePr/>
          <p:nvPr/>
        </p:nvGraphicFramePr>
        <p:xfrm>
          <a:off x="685800" y="789120"/>
          <a:ext cx="5791320" cy="6392880"/>
        </p:xfrm>
        <a:graphic>
          <a:graphicData uri="http://schemas.openxmlformats.org/drawingml/2006/table">
            <a:tbl>
              <a:tblPr/>
              <a:tblGrid>
                <a:gridCol w="1127160"/>
                <a:gridCol w="777960"/>
                <a:gridCol w="761760"/>
                <a:gridCol w="685800"/>
                <a:gridCol w="685800"/>
                <a:gridCol w="685800"/>
                <a:gridCol w="1067040"/>
              </a:tblGrid>
              <a:tr h="337320">
                <a:tc gridSpan="7"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upplementary Table 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Primary Antibody Li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590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bo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tologue 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end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B Dilu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HC Dilu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F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lu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escrip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ouse monoclonal TDP-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E2-E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vus Biological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:2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:3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cognizing human TDP-43 at amino acids 202-2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abbit polyclonal TDP-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782-2-A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oteinTech Grou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5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ade to amino acids 1-26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abbit polyclonal C-terminal TDP-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892-1-A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oteinTech Grou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ade to amino acids 260-4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abbit phospho-TPD-43 (pS403/404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IP-PTD-P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smo Bi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abbit phospho-TPD-43 (pS409/410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IP-PTD-P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smo Bi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ubiquit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5-9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hemicon/ Millipor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60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4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ytochrome c oxidase subunit IV (COX-IV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b160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bca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3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leaved caspase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6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ell Signal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FA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020-U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iogenex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5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ba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19-197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Wak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3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06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APD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eu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est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8634O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b3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54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iodesign Internation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illipor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igma-Aldric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"/>
          <p:cNvGraphicFramePr/>
          <p:nvPr/>
        </p:nvGraphicFramePr>
        <p:xfrm>
          <a:off x="685800" y="762120"/>
          <a:ext cx="5638680" cy="5010120"/>
        </p:xfrm>
        <a:graphic>
          <a:graphicData uri="http://schemas.openxmlformats.org/drawingml/2006/table">
            <a:tbl>
              <a:tblPr/>
              <a:tblGrid>
                <a:gridCol w="1981080"/>
                <a:gridCol w="914400"/>
                <a:gridCol w="914400"/>
                <a:gridCol w="914400"/>
                <a:gridCol w="914400"/>
              </a:tblGrid>
              <a:tr h="370440">
                <a:tc gridSpan="5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upplementary Table 2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Summary of iTDP-43</a:t>
                      </a:r>
                      <a:r>
                        <a:rPr b="0" lang="en-US" sz="8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T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d diTDP-43</a:t>
                      </a:r>
                      <a:r>
                        <a:rPr b="0" lang="en-US" sz="8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T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Patholog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atholog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a di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a i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Symptomatic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d i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Symptomatic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d i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uronal loss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gressive, ag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vere, earl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vere, earl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gressive,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arl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NEL-positive immunoreactivity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 (n=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 (n= 3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tive caspase 3 immunoreactivity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 (n= 3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 (n= 3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 (n= 3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TDP-43 aggregates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creased Ubiquitination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bi/pTDP-43 aggregate colocalization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/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/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/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active microglia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active astrocytes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itochondrial aggregates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/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DP-43 low molecular weight species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+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/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/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TDP-43 cytoplasmic immunoreactivity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+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n=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24040">
                <a:tc gridSpan="5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= none, +/- = variable, + = weak, ++ =  moderate, +++ = strong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 = only examined in 45 day old mice. b = decreases with age. c= increases with age. d = only observed following extended post-mortem interval (5 minutes). Ubi= ubiquitin. pTDP-43=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osphorylation-specific TDP-43 (pS409/410)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here n is not noted &gt;5 animals were examined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7T21:55:21Z</dcterms:created>
  <dc:creator>Mayo Clinic</dc:creator>
  <dc:description/>
  <dc:language>en-US</dc:language>
  <cp:lastModifiedBy>Ashley D Cannon</cp:lastModifiedBy>
  <dcterms:modified xsi:type="dcterms:W3CDTF">2012-04-24T14:04:26Z</dcterms:modified>
  <cp:revision>14</cp:revision>
  <dc:subject/>
  <dc:title>Slide 1</dc:title>
</cp:coreProperties>
</file>